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05324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527132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25510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58954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64033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16780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015590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9864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5001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93817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51728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ACC10-8FB8-413E-AF74-078481BBC614}" type="datetimeFigureOut">
              <a:rPr lang="en-SG" smtClean="0"/>
              <a:t>28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0741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676" y="804806"/>
            <a:ext cx="3240000" cy="7250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936474" y="591426"/>
            <a:ext cx="4903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YF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51876" y="591426"/>
            <a:ext cx="4839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ut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89845" y="591426"/>
            <a:ext cx="651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34815" y="589362"/>
            <a:ext cx="572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gh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3"/>
          <p:cNvSpPr txBox="1"/>
          <p:nvPr/>
        </p:nvSpPr>
        <p:spPr>
          <a:xfrm>
            <a:off x="4016110" y="1090552"/>
            <a:ext cx="142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sTPS1-YF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676" y="1576911"/>
            <a:ext cx="3240000" cy="8052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3"/>
          <p:cNvSpPr txBox="1"/>
          <p:nvPr/>
        </p:nvSpPr>
        <p:spPr>
          <a:xfrm>
            <a:off x="4016110" y="1841397"/>
            <a:ext cx="142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sTPS2-YF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755890" y="3194086"/>
            <a:ext cx="3253846" cy="811617"/>
            <a:chOff x="755890" y="3617984"/>
            <a:chExt cx="3253846" cy="811617"/>
          </a:xfrm>
        </p:grpSpPr>
        <p:pic>
          <p:nvPicPr>
            <p:cNvPr id="13" name="Picture 2"/>
            <p:cNvPicPr preferRelativeResize="0"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570999" y="3618836"/>
              <a:ext cx="1624050" cy="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" name="Picture 3"/>
            <p:cNvPicPr preferRelativeResize="0"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755890" y="3617984"/>
              <a:ext cx="810000" cy="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" name="Picture 4"/>
            <p:cNvPicPr preferRelativeResize="0"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204157" y="3619601"/>
              <a:ext cx="805579" cy="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6" name="TextBox 15"/>
          <p:cNvSpPr txBox="1"/>
          <p:nvPr/>
        </p:nvSpPr>
        <p:spPr>
          <a:xfrm>
            <a:off x="934638" y="2952196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CFP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03418" y="2952196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YFP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472696" y="2952196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Merged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408800" y="295219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Light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4017434" y="3295039"/>
            <a:ext cx="11397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sTPS1-YFP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752331" y="4054826"/>
            <a:ext cx="3259640" cy="814334"/>
            <a:chOff x="752331" y="4495658"/>
            <a:chExt cx="3259640" cy="814334"/>
          </a:xfrm>
        </p:grpSpPr>
        <p:pic>
          <p:nvPicPr>
            <p:cNvPr id="22" name="Picture 6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52331" y="4495658"/>
              <a:ext cx="810000" cy="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3" name="Picture 7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572458" y="4499992"/>
              <a:ext cx="1622217" cy="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" name="Picture 8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208642" y="4499992"/>
              <a:ext cx="803329" cy="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5" name="TextBox 3"/>
          <p:cNvSpPr txBox="1"/>
          <p:nvPr/>
        </p:nvSpPr>
        <p:spPr>
          <a:xfrm>
            <a:off x="4017434" y="4135502"/>
            <a:ext cx="11397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sTPS2-YFP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39537" y="5301208"/>
            <a:ext cx="1370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dditional file 9</a:t>
            </a:r>
            <a:endParaRPr lang="en-SG" sz="14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365852" y="20608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SG" dirty="0"/>
          </a:p>
        </p:txBody>
      </p:sp>
      <p:sp>
        <p:nvSpPr>
          <p:cNvPr id="3" name="TextBox 2"/>
          <p:cNvSpPr txBox="1"/>
          <p:nvPr/>
        </p:nvSpPr>
        <p:spPr>
          <a:xfrm>
            <a:off x="395536" y="458112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SG" dirty="0"/>
          </a:p>
        </p:txBody>
      </p:sp>
    </p:spTree>
    <p:extLst>
      <p:ext uri="{BB962C8B-B14F-4D97-AF65-F5344CB8AC3E}">
        <p14:creationId xmlns:p14="http://schemas.microsoft.com/office/powerpoint/2010/main" val="2673474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1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ojam Rajani</dc:creator>
  <cp:lastModifiedBy>Sarojam Rajani</cp:lastModifiedBy>
  <cp:revision>12</cp:revision>
  <dcterms:created xsi:type="dcterms:W3CDTF">2014-02-05T09:43:27Z</dcterms:created>
  <dcterms:modified xsi:type="dcterms:W3CDTF">2014-05-28T08:02:07Z</dcterms:modified>
</cp:coreProperties>
</file>